
<file path=[Content_Types].xml><?xml version="1.0" encoding="utf-8"?>
<Types xmlns="http://schemas.openxmlformats.org/package/2006/content-types">
  <Default Extension="gif" ContentType="image/gi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0" r:id="rId3"/>
    <p:sldId id="257" r:id="rId4"/>
    <p:sldId id="258" r:id="rId5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88233EDA-F6B5-4171-9DDC-277FB4EF93DB}" v="6" dt="2023-05-19T07:29:00.957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23" autoAdjust="0"/>
    <p:restoredTop sz="94660"/>
  </p:normalViewPr>
  <p:slideViewPr>
    <p:cSldViewPr snapToGrid="0">
      <p:cViewPr varScale="1">
        <p:scale>
          <a:sx n="78" d="100"/>
          <a:sy n="78" d="100"/>
        </p:scale>
        <p:origin x="132" y="3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11" Type="http://schemas.microsoft.com/office/2015/10/relationships/revisionInfo" Target="revisionInfo.xml"/><Relationship Id="rId5" Type="http://schemas.openxmlformats.org/officeDocument/2006/relationships/slide" Target="slides/slide4.xml"/><Relationship Id="rId10" Type="http://schemas.microsoft.com/office/2016/11/relationships/changesInfo" Target="changesInfos/changesInfo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Buyanbileg Sodnom-ish" userId="9dda759ea2d2b2b5" providerId="LiveId" clId="{88233EDA-F6B5-4171-9DDC-277FB4EF93DB}"/>
    <pc:docChg chg="custSel delSld modSld">
      <pc:chgData name="Buyanbileg Sodnom-ish" userId="9dda759ea2d2b2b5" providerId="LiveId" clId="{88233EDA-F6B5-4171-9DDC-277FB4EF93DB}" dt="2023-05-19T07:31:44.127" v="148" actId="166"/>
      <pc:docMkLst>
        <pc:docMk/>
      </pc:docMkLst>
      <pc:sldChg chg="addSp delSp modSp mod">
        <pc:chgData name="Buyanbileg Sodnom-ish" userId="9dda759ea2d2b2b5" providerId="LiveId" clId="{88233EDA-F6B5-4171-9DDC-277FB4EF93DB}" dt="2023-05-19T07:24:32.265" v="3" actId="478"/>
        <pc:sldMkLst>
          <pc:docMk/>
          <pc:sldMk cId="2638894516" sldId="256"/>
        </pc:sldMkLst>
        <pc:picChg chg="add del mod">
          <ac:chgData name="Buyanbileg Sodnom-ish" userId="9dda759ea2d2b2b5" providerId="LiveId" clId="{88233EDA-F6B5-4171-9DDC-277FB4EF93DB}" dt="2023-05-19T07:24:32.265" v="3" actId="478"/>
          <ac:picMkLst>
            <pc:docMk/>
            <pc:sldMk cId="2638894516" sldId="256"/>
            <ac:picMk id="5" creationId="{1B5C861A-6AB5-D5E0-5AC3-21FD251C508E}"/>
          </ac:picMkLst>
        </pc:picChg>
      </pc:sldChg>
      <pc:sldChg chg="addSp delSp modSp mod">
        <pc:chgData name="Buyanbileg Sodnom-ish" userId="9dda759ea2d2b2b5" providerId="LiveId" clId="{88233EDA-F6B5-4171-9DDC-277FB4EF93DB}" dt="2023-05-19T07:31:34.269" v="146" actId="166"/>
        <pc:sldMkLst>
          <pc:docMk/>
          <pc:sldMk cId="2568672137" sldId="257"/>
        </pc:sldMkLst>
        <pc:spChg chg="ord">
          <ac:chgData name="Buyanbileg Sodnom-ish" userId="9dda759ea2d2b2b5" providerId="LiveId" clId="{88233EDA-F6B5-4171-9DDC-277FB4EF93DB}" dt="2023-05-19T07:31:34.269" v="146" actId="166"/>
          <ac:spMkLst>
            <pc:docMk/>
            <pc:sldMk cId="2568672137" sldId="257"/>
            <ac:spMk id="3" creationId="{A5143807-AAF8-46BF-9FD5-90C8804E5CE9}"/>
          </ac:spMkLst>
        </pc:spChg>
        <pc:picChg chg="del">
          <ac:chgData name="Buyanbileg Sodnom-ish" userId="9dda759ea2d2b2b5" providerId="LiveId" clId="{88233EDA-F6B5-4171-9DDC-277FB4EF93DB}" dt="2023-05-19T07:25:30.197" v="18" actId="478"/>
          <ac:picMkLst>
            <pc:docMk/>
            <pc:sldMk cId="2568672137" sldId="257"/>
            <ac:picMk id="2" creationId="{00000000-0000-0000-0000-000000000000}"/>
          </ac:picMkLst>
        </pc:picChg>
        <pc:picChg chg="add mod">
          <ac:chgData name="Buyanbileg Sodnom-ish" userId="9dda759ea2d2b2b5" providerId="LiveId" clId="{88233EDA-F6B5-4171-9DDC-277FB4EF93DB}" dt="2023-05-19T07:31:31.215" v="145" actId="1076"/>
          <ac:picMkLst>
            <pc:docMk/>
            <pc:sldMk cId="2568672137" sldId="257"/>
            <ac:picMk id="5" creationId="{50222D52-6945-5116-93C3-6CA78088F18D}"/>
          </ac:picMkLst>
        </pc:picChg>
      </pc:sldChg>
      <pc:sldChg chg="addSp delSp modSp mod">
        <pc:chgData name="Buyanbileg Sodnom-ish" userId="9dda759ea2d2b2b5" providerId="LiveId" clId="{88233EDA-F6B5-4171-9DDC-277FB4EF93DB}" dt="2023-05-19T07:31:44.127" v="148" actId="166"/>
        <pc:sldMkLst>
          <pc:docMk/>
          <pc:sldMk cId="53718691" sldId="258"/>
        </pc:sldMkLst>
        <pc:spChg chg="mod ord">
          <ac:chgData name="Buyanbileg Sodnom-ish" userId="9dda759ea2d2b2b5" providerId="LiveId" clId="{88233EDA-F6B5-4171-9DDC-277FB4EF93DB}" dt="2023-05-19T07:31:44.127" v="148" actId="166"/>
          <ac:spMkLst>
            <pc:docMk/>
            <pc:sldMk cId="53718691" sldId="258"/>
            <ac:spMk id="3" creationId="{782D0ECD-BD71-48A1-972C-54F57926DFC4}"/>
          </ac:spMkLst>
        </pc:spChg>
        <pc:spChg chg="add mod">
          <ac:chgData name="Buyanbileg Sodnom-ish" userId="9dda759ea2d2b2b5" providerId="LiveId" clId="{88233EDA-F6B5-4171-9DDC-277FB4EF93DB}" dt="2023-05-19T07:30:41.121" v="143" actId="14100"/>
          <ac:spMkLst>
            <pc:docMk/>
            <pc:sldMk cId="53718691" sldId="258"/>
            <ac:spMk id="6" creationId="{0A3222E1-614C-E606-7BD7-471AACB94A10}"/>
          </ac:spMkLst>
        </pc:spChg>
        <pc:picChg chg="del">
          <ac:chgData name="Buyanbileg Sodnom-ish" userId="9dda759ea2d2b2b5" providerId="LiveId" clId="{88233EDA-F6B5-4171-9DDC-277FB4EF93DB}" dt="2023-05-19T07:25:56.430" v="21" actId="478"/>
          <ac:picMkLst>
            <pc:docMk/>
            <pc:sldMk cId="53718691" sldId="258"/>
            <ac:picMk id="2" creationId="{00000000-0000-0000-0000-000000000000}"/>
          </ac:picMkLst>
        </pc:picChg>
        <pc:picChg chg="add mod">
          <ac:chgData name="Buyanbileg Sodnom-ish" userId="9dda759ea2d2b2b5" providerId="LiveId" clId="{88233EDA-F6B5-4171-9DDC-277FB4EF93DB}" dt="2023-05-19T07:31:40.516" v="147" actId="1076"/>
          <ac:picMkLst>
            <pc:docMk/>
            <pc:sldMk cId="53718691" sldId="258"/>
            <ac:picMk id="5" creationId="{53C78C2E-1652-89DE-73A4-F12E2FCA06BB}"/>
          </ac:picMkLst>
        </pc:picChg>
      </pc:sldChg>
      <pc:sldChg chg="delSp del mod">
        <pc:chgData name="Buyanbileg Sodnom-ish" userId="9dda759ea2d2b2b5" providerId="LiveId" clId="{88233EDA-F6B5-4171-9DDC-277FB4EF93DB}" dt="2023-05-19T07:26:49.279" v="27" actId="47"/>
        <pc:sldMkLst>
          <pc:docMk/>
          <pc:sldMk cId="2711566437" sldId="259"/>
        </pc:sldMkLst>
        <pc:picChg chg="del">
          <ac:chgData name="Buyanbileg Sodnom-ish" userId="9dda759ea2d2b2b5" providerId="LiveId" clId="{88233EDA-F6B5-4171-9DDC-277FB4EF93DB}" dt="2023-05-19T07:26:42.544" v="26" actId="478"/>
          <ac:picMkLst>
            <pc:docMk/>
            <pc:sldMk cId="2711566437" sldId="259"/>
            <ac:picMk id="2" creationId="{00000000-0000-0000-0000-000000000000}"/>
          </ac:picMkLst>
        </pc:picChg>
      </pc:sldChg>
      <pc:sldChg chg="addSp delSp modSp mod">
        <pc:chgData name="Buyanbileg Sodnom-ish" userId="9dda759ea2d2b2b5" providerId="LiveId" clId="{88233EDA-F6B5-4171-9DDC-277FB4EF93DB}" dt="2023-05-19T07:31:23.878" v="144" actId="1076"/>
        <pc:sldMkLst>
          <pc:docMk/>
          <pc:sldMk cId="3647654834" sldId="260"/>
        </pc:sldMkLst>
        <pc:spChg chg="mod">
          <ac:chgData name="Buyanbileg Sodnom-ish" userId="9dda759ea2d2b2b5" providerId="LiveId" clId="{88233EDA-F6B5-4171-9DDC-277FB4EF93DB}" dt="2023-05-19T07:25:18.706" v="13" actId="20577"/>
          <ac:spMkLst>
            <pc:docMk/>
            <pc:sldMk cId="3647654834" sldId="260"/>
            <ac:spMk id="4" creationId="{1107A156-9176-400F-B9AC-5EE20D494C72}"/>
          </ac:spMkLst>
        </pc:spChg>
        <pc:spChg chg="add mod">
          <ac:chgData name="Buyanbileg Sodnom-ish" userId="9dda759ea2d2b2b5" providerId="LiveId" clId="{88233EDA-F6B5-4171-9DDC-277FB4EF93DB}" dt="2023-05-19T07:28:57.569" v="122" actId="1076"/>
          <ac:spMkLst>
            <pc:docMk/>
            <pc:sldMk cId="3647654834" sldId="260"/>
            <ac:spMk id="6" creationId="{54E9E1EA-261D-998E-A8EA-EAC55657F132}"/>
          </ac:spMkLst>
        </pc:spChg>
        <pc:picChg chg="del">
          <ac:chgData name="Buyanbileg Sodnom-ish" userId="9dda759ea2d2b2b5" providerId="LiveId" clId="{88233EDA-F6B5-4171-9DDC-277FB4EF93DB}" dt="2023-05-19T07:24:38.866" v="8" actId="478"/>
          <ac:picMkLst>
            <pc:docMk/>
            <pc:sldMk cId="3647654834" sldId="260"/>
            <ac:picMk id="3" creationId="{00000000-0000-0000-0000-000000000000}"/>
          </ac:picMkLst>
        </pc:picChg>
        <pc:picChg chg="add mod">
          <ac:chgData name="Buyanbileg Sodnom-ish" userId="9dda759ea2d2b2b5" providerId="LiveId" clId="{88233EDA-F6B5-4171-9DDC-277FB4EF93DB}" dt="2023-05-19T07:31:23.878" v="144" actId="1076"/>
          <ac:picMkLst>
            <pc:docMk/>
            <pc:sldMk cId="3647654834" sldId="260"/>
            <ac:picMk id="5" creationId="{54E55848-C30A-30B8-25C4-F2A7F8F11541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303D9-A3A6-4A7C-AA23-517B5D2F2BB2}" type="datetimeFigureOut">
              <a:rPr lang="ko-KR" altLang="en-US" smtClean="0"/>
              <a:t>2023-05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E48AB-E0A1-4C7C-9A2A-9E07E56BC4C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783515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303D9-A3A6-4A7C-AA23-517B5D2F2BB2}" type="datetimeFigureOut">
              <a:rPr lang="ko-KR" altLang="en-US" smtClean="0"/>
              <a:t>2023-05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E48AB-E0A1-4C7C-9A2A-9E07E56BC4C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013170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303D9-A3A6-4A7C-AA23-517B5D2F2BB2}" type="datetimeFigureOut">
              <a:rPr lang="ko-KR" altLang="en-US" smtClean="0"/>
              <a:t>2023-05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E48AB-E0A1-4C7C-9A2A-9E07E56BC4C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710416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303D9-A3A6-4A7C-AA23-517B5D2F2BB2}" type="datetimeFigureOut">
              <a:rPr lang="ko-KR" altLang="en-US" smtClean="0"/>
              <a:t>2023-05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E48AB-E0A1-4C7C-9A2A-9E07E56BC4C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311603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303D9-A3A6-4A7C-AA23-517B5D2F2BB2}" type="datetimeFigureOut">
              <a:rPr lang="ko-KR" altLang="en-US" smtClean="0"/>
              <a:t>2023-05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E48AB-E0A1-4C7C-9A2A-9E07E56BC4C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3748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303D9-A3A6-4A7C-AA23-517B5D2F2BB2}" type="datetimeFigureOut">
              <a:rPr lang="ko-KR" altLang="en-US" smtClean="0"/>
              <a:t>2023-05-1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E48AB-E0A1-4C7C-9A2A-9E07E56BC4C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371090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303D9-A3A6-4A7C-AA23-517B5D2F2BB2}" type="datetimeFigureOut">
              <a:rPr lang="ko-KR" altLang="en-US" smtClean="0"/>
              <a:t>2023-05-19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E48AB-E0A1-4C7C-9A2A-9E07E56BC4C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693186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303D9-A3A6-4A7C-AA23-517B5D2F2BB2}" type="datetimeFigureOut">
              <a:rPr lang="ko-KR" altLang="en-US" smtClean="0"/>
              <a:t>2023-05-19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E48AB-E0A1-4C7C-9A2A-9E07E56BC4C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072149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303D9-A3A6-4A7C-AA23-517B5D2F2BB2}" type="datetimeFigureOut">
              <a:rPr lang="ko-KR" altLang="en-US" smtClean="0"/>
              <a:t>2023-05-19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E48AB-E0A1-4C7C-9A2A-9E07E56BC4C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568359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303D9-A3A6-4A7C-AA23-517B5D2F2BB2}" type="datetimeFigureOut">
              <a:rPr lang="ko-KR" altLang="en-US" smtClean="0"/>
              <a:t>2023-05-1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E48AB-E0A1-4C7C-9A2A-9E07E56BC4C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783339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303D9-A3A6-4A7C-AA23-517B5D2F2BB2}" type="datetimeFigureOut">
              <a:rPr lang="ko-KR" altLang="en-US" smtClean="0"/>
              <a:t>2023-05-1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E48AB-E0A1-4C7C-9A2A-9E07E56BC4C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865904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9303D9-A3A6-4A7C-AA23-517B5D2F2BB2}" type="datetimeFigureOut">
              <a:rPr lang="ko-KR" altLang="en-US" smtClean="0"/>
              <a:t>2023-05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3E48AB-E0A1-4C7C-9A2A-9E07E56BC4C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192270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gi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gi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gif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g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43688" y="0"/>
            <a:ext cx="4745491" cy="6858000"/>
          </a:xfrm>
          <a:prstGeom prst="rect">
            <a:avLst/>
          </a:prstGeom>
        </p:spPr>
      </p:pic>
      <p:sp>
        <p:nvSpPr>
          <p:cNvPr id="2" name="Rectangle 1">
            <a:extLst>
              <a:ext uri="{FF2B5EF4-FFF2-40B4-BE49-F238E27FC236}">
                <a16:creationId xmlns:a16="http://schemas.microsoft.com/office/drawing/2014/main" id="{C20B7C27-10A1-4257-9FD3-BFAECED83553}"/>
              </a:ext>
            </a:extLst>
          </p:cNvPr>
          <p:cNvSpPr/>
          <p:nvPr/>
        </p:nvSpPr>
        <p:spPr>
          <a:xfrm>
            <a:off x="7480664" y="2636410"/>
            <a:ext cx="4249782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285750" indent="-285750" algn="just" eaLnBrk="0" latinLnBrk="0" hangingPunct="0">
              <a:buFont typeface="Arial" panose="020B0604020202020204" pitchFamily="34" charset="0"/>
              <a:buChar char="•"/>
            </a:pPr>
            <a:r>
              <a:rPr lang="en-US" kern="100" dirty="0" err="1">
                <a:latin typeface="Times New Roman" panose="02020603050405020304" pitchFamily="18" charset="0"/>
                <a:ea typeface="맑은 고딕" panose="020B0503020000020004" pitchFamily="50" charset="-127"/>
              </a:rPr>
              <a:t>Sialomicroliths</a:t>
            </a:r>
            <a:r>
              <a:rPr lang="en-US" kern="100" dirty="0">
                <a:latin typeface="Times New Roman" panose="02020603050405020304" pitchFamily="18" charset="0"/>
                <a:ea typeface="맑은 고딕" panose="020B0503020000020004" pitchFamily="50" charset="-127"/>
              </a:rPr>
              <a:t> are microscopic concretions of the salivary gland and are found in asymptomatic individuals.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3889451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1107A156-9176-400F-B9AC-5EE20D494C72}"/>
              </a:ext>
            </a:extLst>
          </p:cNvPr>
          <p:cNvSpPr/>
          <p:nvPr/>
        </p:nvSpPr>
        <p:spPr>
          <a:xfrm>
            <a:off x="7419703" y="1305341"/>
            <a:ext cx="4450081" cy="397031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285750" indent="-285750" algn="just" eaLnBrk="0" latinLnBrk="0" hangingPunct="0">
              <a:buFont typeface="Arial" panose="020B0604020202020204" pitchFamily="34" charset="0"/>
              <a:buChar char="•"/>
            </a:pPr>
            <a:r>
              <a:rPr lang="en-US" kern="100" dirty="0">
                <a:latin typeface="Times New Roman" panose="02020603050405020304" pitchFamily="18" charset="0"/>
                <a:ea typeface="맑은 고딕" panose="020B0503020000020004" pitchFamily="50" charset="-127"/>
              </a:rPr>
              <a:t>During salivary stagnation or secretory inactivity, bacterial infection occurs with biofilm formation cross-linked with salivary protein.</a:t>
            </a:r>
          </a:p>
          <a:p>
            <a:pPr marL="285750" indent="-285750" algn="just" eaLnBrk="0" latinLnBrk="0" hangingPunct="0">
              <a:buFont typeface="Arial" panose="020B0604020202020204" pitchFamily="34" charset="0"/>
              <a:buChar char="•"/>
            </a:pPr>
            <a:endParaRPr lang="en-US" kern="100" dirty="0">
              <a:latin typeface="Times New Roman" panose="02020603050405020304" pitchFamily="18" charset="0"/>
              <a:ea typeface="맑은 고딕" panose="020B0503020000020004" pitchFamily="50" charset="-127"/>
            </a:endParaRPr>
          </a:p>
          <a:p>
            <a:pPr marL="285750" indent="-285750" algn="just" eaLnBrk="0" latinLnBrk="0" hangingPunct="0">
              <a:buFont typeface="Arial" panose="020B0604020202020204" pitchFamily="34" charset="0"/>
              <a:buChar char="•"/>
            </a:pPr>
            <a:r>
              <a:rPr lang="en-US" kern="100" dirty="0">
                <a:latin typeface="Times New Roman" panose="02020603050405020304" pitchFamily="18" charset="0"/>
                <a:ea typeface="맑은 고딕" panose="020B0503020000020004" pitchFamily="50" charset="-127"/>
              </a:rPr>
              <a:t>Secretory inactivity is a factor leading to the accumulation of </a:t>
            </a:r>
            <a:r>
              <a:rPr lang="en-US" kern="100" dirty="0" err="1">
                <a:latin typeface="Times New Roman" panose="02020603050405020304" pitchFamily="18" charset="0"/>
                <a:ea typeface="맑은 고딕" panose="020B0503020000020004" pitchFamily="50" charset="-127"/>
              </a:rPr>
              <a:t>sialomicroliths</a:t>
            </a:r>
            <a:r>
              <a:rPr lang="en-US" kern="100" dirty="0">
                <a:latin typeface="Times New Roman" panose="02020603050405020304" pitchFamily="18" charset="0"/>
                <a:ea typeface="맑은 고딕" panose="020B0503020000020004" pitchFamily="50" charset="-127"/>
              </a:rPr>
              <a:t>, with obstructive atrophy, inflammation, and compression of the surrounding parenchyma resulting in stagnation of saliva excretion, thus creating an environment for calcium deposition on phospholipid membranes and creating a </a:t>
            </a:r>
            <a:r>
              <a:rPr lang="en-US" kern="100" dirty="0" err="1">
                <a:latin typeface="Times New Roman" panose="02020603050405020304" pitchFamily="18" charset="0"/>
                <a:ea typeface="맑은 고딕" panose="020B0503020000020004" pitchFamily="50" charset="-127"/>
              </a:rPr>
              <a:t>sialolith</a:t>
            </a:r>
            <a:r>
              <a:rPr lang="en-US" kern="100" dirty="0">
                <a:latin typeface="Times New Roman" panose="02020603050405020304" pitchFamily="18" charset="0"/>
                <a:ea typeface="맑은 고딕" panose="020B0503020000020004" pitchFamily="50" charset="-127"/>
              </a:rPr>
              <a:t>.</a:t>
            </a:r>
          </a:p>
        </p:txBody>
      </p:sp>
      <p:pic>
        <p:nvPicPr>
          <p:cNvPr id="5" name="Picture 4" descr="A picture containing marine invertebrates&#10;&#10;Description automatically generated">
            <a:extLst>
              <a:ext uri="{FF2B5EF4-FFF2-40B4-BE49-F238E27FC236}">
                <a16:creationId xmlns:a16="http://schemas.microsoft.com/office/drawing/2014/main" id="{54E55848-C30A-30B8-25C4-F2A7F8F1154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43784" y="0"/>
            <a:ext cx="4734922" cy="68580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54E9E1EA-261D-998E-A8EA-EAC55657F132}"/>
              </a:ext>
            </a:extLst>
          </p:cNvPr>
          <p:cNvSpPr txBox="1"/>
          <p:nvPr/>
        </p:nvSpPr>
        <p:spPr>
          <a:xfrm>
            <a:off x="6347637" y="323062"/>
            <a:ext cx="3466214" cy="659218"/>
          </a:xfrm>
          <a:prstGeom prst="rect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cterial biofilm cross-linked with salivary protein</a:t>
            </a:r>
          </a:p>
        </p:txBody>
      </p:sp>
    </p:spTree>
    <p:extLst>
      <p:ext uri="{BB962C8B-B14F-4D97-AF65-F5344CB8AC3E}">
        <p14:creationId xmlns:p14="http://schemas.microsoft.com/office/powerpoint/2010/main" val="364765483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diagram of a large intestine&#10;&#10;Description automatically generated with medium confidence">
            <a:extLst>
              <a:ext uri="{FF2B5EF4-FFF2-40B4-BE49-F238E27FC236}">
                <a16:creationId xmlns:a16="http://schemas.microsoft.com/office/drawing/2014/main" id="{50222D52-6945-5116-93C3-6CA78088F18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43784" y="0"/>
            <a:ext cx="4997929" cy="6858000"/>
          </a:xfrm>
          <a:prstGeom prst="rect">
            <a:avLst/>
          </a:prstGeom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A5143807-AAF8-46BF-9FD5-90C8804E5CE9}"/>
              </a:ext>
            </a:extLst>
          </p:cNvPr>
          <p:cNvSpPr/>
          <p:nvPr/>
        </p:nvSpPr>
        <p:spPr>
          <a:xfrm>
            <a:off x="7399825" y="2690335"/>
            <a:ext cx="4450081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285750" indent="-285750" algn="just" eaLnBrk="0" latinLnBrk="0" hangingPunct="0">
              <a:buFont typeface="Arial" panose="020B0604020202020204" pitchFamily="34" charset="0"/>
              <a:buChar char="•"/>
            </a:pPr>
            <a:r>
              <a:rPr lang="en-US" kern="100" dirty="0">
                <a:latin typeface="Times New Roman" panose="02020603050405020304" pitchFamily="18" charset="0"/>
                <a:ea typeface="맑은 고딕" panose="020B0503020000020004" pitchFamily="50" charset="-127"/>
              </a:rPr>
              <a:t>The induction of an inflammatory reaction can cause an influx of neutrophils into the salivary duct. </a:t>
            </a:r>
          </a:p>
          <a:p>
            <a:pPr marL="285750" indent="-285750" algn="just" eaLnBrk="0" latinLnBrk="0" hangingPunct="0">
              <a:buFont typeface="Arial" panose="020B0604020202020204" pitchFamily="34" charset="0"/>
              <a:buChar char="•"/>
            </a:pPr>
            <a:endParaRPr lang="en-US" kern="100" dirty="0">
              <a:latin typeface="Times New Roman" panose="02020603050405020304" pitchFamily="18" charset="0"/>
              <a:ea typeface="맑은 고딕" panose="020B0503020000020004" pitchFamily="50" charset="-127"/>
            </a:endParaRPr>
          </a:p>
          <a:p>
            <a:pPr marL="285750" indent="-285750" algn="just" eaLnBrk="0" latinLnBrk="0" hangingPunct="0">
              <a:buFont typeface="Arial" panose="020B0604020202020204" pitchFamily="34" charset="0"/>
              <a:buChar char="•"/>
            </a:pPr>
            <a:endParaRPr lang="en-US" kern="100" dirty="0">
              <a:latin typeface="Times New Roman" panose="02020603050405020304" pitchFamily="18" charset="0"/>
              <a:ea typeface="맑은 고딕" panose="020B0503020000020004" pitchFamily="50" charset="-127"/>
            </a:endParaRPr>
          </a:p>
        </p:txBody>
      </p:sp>
    </p:spTree>
    <p:extLst>
      <p:ext uri="{BB962C8B-B14F-4D97-AF65-F5344CB8AC3E}">
        <p14:creationId xmlns:p14="http://schemas.microsoft.com/office/powerpoint/2010/main" val="256867213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diagram of a large intestine&#10;&#10;Description automatically generated with medium confidence">
            <a:extLst>
              <a:ext uri="{FF2B5EF4-FFF2-40B4-BE49-F238E27FC236}">
                <a16:creationId xmlns:a16="http://schemas.microsoft.com/office/drawing/2014/main" id="{53C78C2E-1652-89DE-73A4-F12E2FCA06B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43784" y="92335"/>
            <a:ext cx="4837270" cy="68580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0A3222E1-614C-E606-7BD7-471AACB94A10}"/>
              </a:ext>
            </a:extLst>
          </p:cNvPr>
          <p:cNvSpPr txBox="1"/>
          <p:nvPr/>
        </p:nvSpPr>
        <p:spPr>
          <a:xfrm>
            <a:off x="6347637" y="323062"/>
            <a:ext cx="2126512" cy="369332"/>
          </a:xfrm>
          <a:prstGeom prst="rect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condary infection</a:t>
            </a: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782D0ECD-BD71-48A1-972C-54F57926DFC4}"/>
              </a:ext>
            </a:extLst>
          </p:cNvPr>
          <p:cNvSpPr/>
          <p:nvPr/>
        </p:nvSpPr>
        <p:spPr>
          <a:xfrm>
            <a:off x="7419703" y="1305341"/>
            <a:ext cx="4450081" cy="258532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285750" indent="-285750" algn="just" eaLnBrk="0" latinLnBrk="0" hangingPunct="0">
              <a:buFont typeface="Arial" panose="020B0604020202020204" pitchFamily="34" charset="0"/>
              <a:buChar char="•"/>
            </a:pPr>
            <a:endParaRPr lang="en-US" kern="100" dirty="0">
              <a:latin typeface="Times New Roman" panose="02020603050405020304" pitchFamily="18" charset="0"/>
              <a:ea typeface="맑은 고딕" panose="020B0503020000020004" pitchFamily="50" charset="-127"/>
            </a:endParaRPr>
          </a:p>
          <a:p>
            <a:pPr marL="285750" indent="-285750" algn="just" eaLnBrk="0" latinLnBrk="0" hangingPunct="0">
              <a:buFont typeface="Arial" panose="020B0604020202020204" pitchFamily="34" charset="0"/>
              <a:buChar char="•"/>
            </a:pPr>
            <a:r>
              <a:rPr lang="en-US" kern="100" dirty="0">
                <a:latin typeface="Times New Roman" panose="02020603050405020304" pitchFamily="18" charset="0"/>
                <a:ea typeface="맑은 고딕" panose="020B0503020000020004" pitchFamily="50" charset="-127"/>
              </a:rPr>
              <a:t>The activation of neutrophils cells can form neutrophil extracellular traps (NETs), which are potent attractors of calcium-based crystals (hydroxyapatite, brushite, and whitlockite), and promote the pathogenesis of sialolithiasis </a:t>
            </a:r>
          </a:p>
          <a:p>
            <a:pPr marL="285750" indent="-285750" algn="just" eaLnBrk="0" latinLnBrk="0" hangingPunct="0">
              <a:buFont typeface="Arial" panose="020B0604020202020204" pitchFamily="34" charset="0"/>
              <a:buChar char="•"/>
            </a:pPr>
            <a:r>
              <a:rPr lang="en-US" sz="1800" kern="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Secondary infection with oral common bacteria occurs.</a:t>
            </a:r>
            <a:endParaRPr lang="en-US" kern="100" dirty="0">
              <a:latin typeface="Times New Roman" panose="02020603050405020304" pitchFamily="18" charset="0"/>
              <a:ea typeface="맑은 고딕" panose="020B0503020000020004" pitchFamily="50" charset="-127"/>
            </a:endParaRPr>
          </a:p>
        </p:txBody>
      </p:sp>
    </p:spTree>
    <p:extLst>
      <p:ext uri="{BB962C8B-B14F-4D97-AF65-F5344CB8AC3E}">
        <p14:creationId xmlns:p14="http://schemas.microsoft.com/office/powerpoint/2010/main" val="537186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</TotalTime>
  <Words>146</Words>
  <Application>Microsoft Office PowerPoint</Application>
  <PresentationFormat>Widescreen</PresentationFormat>
  <Paragraphs>10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맑은 고딕</vt:lpstr>
      <vt:lpstr>Arial</vt:lpstr>
      <vt:lpstr>Times New Roman</vt:lpstr>
      <vt:lpstr>Office 테마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SNU</dc:creator>
  <cp:lastModifiedBy>Buyanbileg Sodnom-ish</cp:lastModifiedBy>
  <cp:revision>4</cp:revision>
  <dcterms:created xsi:type="dcterms:W3CDTF">2022-11-16T08:51:53Z</dcterms:created>
  <dcterms:modified xsi:type="dcterms:W3CDTF">2023-05-19T07:31:47Z</dcterms:modified>
</cp:coreProperties>
</file>